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C6924-BDD1-4785-A3B7-5E9A6E0117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3B988-CF9F-4E27-B34F-3D0B5117E2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21C6B-5F8C-4DBB-BFA7-B1C908BD1E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8E637-98A4-4850-8EDF-FF82A5AF34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E8C19-91A5-427A-9299-96C6577C2A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387CD-5584-4122-9CCD-43238CED17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EB12E-AA6B-495D-906F-98733A37C6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ABA62-6F07-4492-A1FE-71F4138B87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E3BA2-A79D-4930-8473-5FA729D685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75B5A-6B80-44F6-88FA-B1A18117AB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83274-74BB-49EB-8783-CFBFC200F9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B3B4C-48C5-4F7F-B5A0-C1093CC4D5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60300C-EE92-4E17-B1EB-E61D50B8461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165240" y="127080"/>
            <a:ext cx="895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5 Table. Primers used to make hsp68-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lacZ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transgene construct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771480" y="512640"/>
          <a:ext cx="7629480" cy="6299280"/>
        </p:xfrm>
        <a:graphic>
          <a:graphicData uri="http://schemas.openxmlformats.org/drawingml/2006/table">
            <a:tbl>
              <a:tblPr/>
              <a:tblGrid>
                <a:gridCol w="1949400"/>
                <a:gridCol w="2789280"/>
                <a:gridCol w="2890800"/>
              </a:tblGrid>
              <a:tr h="2746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rget region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ward primers (5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’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’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verse primers (5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’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’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GCTGTCGCCTCTGGTCTCAGCTA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ACAACTGACTGAGGGCTTGAAGGA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TTCTTCTTCGGTTCACTCGGCTC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TGTAGTGGTACACAGAGGTCAGA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a+b+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GCTGTCGCCTCTGGTCTCAGCTA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CCATAGCGGGACTCAGGCTT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d+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AAGCCTGAGTCCCGCTAT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ACAACTGACTGAGGGCTTGAAGGA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AAGCCTGAGTCCCGCTAT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CCTGCAGGTGCTCAGAAAAAAATC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AGATTTTTTTCTGAGCACCTGCA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ACAACTGACTGAGGGCTTGAAGGA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GACCTCTGCACATATATACACA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CCTCGAGTAAAGGCAAATGTGT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AGTCTCCTTCAGGCTACACCATG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TGTCCTCTACAGAGCATGTTGCC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TACATAAACCAGAGGCGAGCC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AAGGGTACCAGGACGGCTGCAA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3+4+5 set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3 with R4 overlappin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TTGCGGCCGCTATGACCTCTGCACATATATACACAC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CTGAAGGAGTAAAGGCAAATGTGTAT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3+4+5 set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4 with R3 and R5 overlappin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CTTTACTCCTTCAGGCTACACCATGG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CTGGTTTATCTACAGAGCATGTTGCCT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3+4+5 set 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5 with R4 overlappin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TCTGTAGATAAACCAGAGGCGAGCCA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TTGCGGCCGCTAAAGGGTACCAGGACGGCTGCAAAT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15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d+e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ＭＳ ゴシック"/>
                          <a:ea typeface="ＭＳ ゴシック"/>
                        </a:rPr>
                        <a:t>Δ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tx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Forward primer with Pitx1 mu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GCGACTGAGTCCCGCTATG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ACAACTGACTGAGGGCTTGAAGGA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15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d+e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ＭＳ ゴシック"/>
                          <a:ea typeface="ＭＳ ゴシック"/>
                        </a:rPr>
                        <a:t>Δ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eb1 set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everse primer with Zeb1 mu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AAACAGGCCTATTTAAGCCTGAGTCCCGCTA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AAACCTGCGAATGCTCAGAAAAAAATC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15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2: d+e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ＭＳ ゴシック"/>
                          <a:ea typeface="ＭＳ ゴシック"/>
                        </a:rPr>
                        <a:t>Δ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eb1 set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Forward primer with Zeb1 mut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ATTTTTTTCTGAGCATTCGCAGGTTTG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TGGCCTGTTTGGCCTATTACAACTGACTGAGGGCTTGAAGGAG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11T06:20:02Z</dcterms:created>
  <dc:creator>CX</dc:creator>
  <dc:description/>
  <dc:language>en-US</dc:language>
  <cp:lastModifiedBy>Capellini, Terence D.</cp:lastModifiedBy>
  <dcterms:modified xsi:type="dcterms:W3CDTF">2016-09-20T20:41:47Z</dcterms:modified>
  <cp:revision>39</cp:revision>
  <dc:subject/>
  <dc:title>PowerPoint Presentation</dc:title>
</cp:coreProperties>
</file>